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7" r:id="rId3"/>
    <p:sldId id="268" r:id="rId4"/>
    <p:sldId id="269" r:id="rId5"/>
    <p:sldId id="266" r:id="rId6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72" autoAdjust="0"/>
    <p:restoredTop sz="94660"/>
  </p:normalViewPr>
  <p:slideViewPr>
    <p:cSldViewPr snapToGrid="0">
      <p:cViewPr varScale="1">
        <p:scale>
          <a:sx n="72" d="100"/>
          <a:sy n="72" d="100"/>
        </p:scale>
        <p:origin x="-1050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927113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773202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713778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4163992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98451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1038348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725476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880611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4152902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3583793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2589139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837F2-2D71-4889-ABBE-8734914D4AD4}" type="datetimeFigureOut">
              <a:rPr lang="zh-TW" altLang="en-US" smtClean="0"/>
              <a:pPr/>
              <a:t>2021/4/26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DE6E5-2D86-4054-809A-C967143B573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xmlns="" val="760741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物件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493842654"/>
              </p:ext>
            </p:extLst>
          </p:nvPr>
        </p:nvGraphicFramePr>
        <p:xfrm>
          <a:off x="4812695" y="1261796"/>
          <a:ext cx="2241078" cy="2043678"/>
        </p:xfrm>
        <a:graphic>
          <a:graphicData uri="http://schemas.openxmlformats.org/presentationml/2006/ole">
            <p:oleObj spid="_x0000_s1028" r:id="rId3" imgW="1838825" imgH="1674462" progId="">
              <p:embed/>
            </p:oleObj>
          </a:graphicData>
        </a:graphic>
      </p:graphicFrame>
      <p:sp>
        <p:nvSpPr>
          <p:cNvPr id="26" name="矩形 25"/>
          <p:cNvSpPr/>
          <p:nvPr/>
        </p:nvSpPr>
        <p:spPr>
          <a:xfrm>
            <a:off x="3538331" y="3628206"/>
            <a:ext cx="481054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1647995"/>
            <a:r>
              <a:rPr lang="en-US" altLang="zh-TW" sz="1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,4-Dimethoxy-6-methylbenzene-1,3-diol </a:t>
            </a:r>
            <a:r>
              <a:rPr lang="en-US" altLang="zh-TW" sz="1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MD)</a:t>
            </a:r>
            <a:endParaRPr lang="zh-TW" altLang="en-US" sz="1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2905760" y="4678549"/>
            <a:ext cx="74168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igure </a:t>
            </a:r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The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chemical structure of DMD.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63845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750244" y="845667"/>
            <a:ext cx="8088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6433878" y="854806"/>
            <a:ext cx="102617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圖片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064421" y="1685461"/>
            <a:ext cx="3818086" cy="2675380"/>
          </a:xfrm>
          <a:prstGeom prst="rect">
            <a:avLst/>
          </a:prstGeom>
        </p:spPr>
      </p:pic>
      <p:pic>
        <p:nvPicPr>
          <p:cNvPr id="4" name="圖片 3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59136" y="1685461"/>
            <a:ext cx="3818086" cy="267538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978580" y="4706281"/>
            <a:ext cx="10390459" cy="1200329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/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Cell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viability in 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BMDMs determined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by MTT assay after incubation with 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(A) IMQ and (B) DMD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in the indicated concentration, respectively, for 24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 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h (</a:t>
            </a:r>
            <a:r>
              <a:rPr lang="en-US" altLang="zh-TW" i="1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n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=3)</a:t>
            </a:r>
            <a:r>
              <a:rPr lang="en-US" altLang="zh-TW" dirty="0" smtClean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.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The data shown are representative of three independent experiments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. </a:t>
            </a:r>
            <a:r>
              <a:rPr lang="en-US" altLang="zh-TW" i="1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*P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 &lt; 0.05, </a:t>
            </a:r>
            <a:r>
              <a:rPr lang="en-US" altLang="zh-TW" i="1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**P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&lt; 0.01</a:t>
            </a:r>
            <a:r>
              <a:rPr lang="en-US" altLang="zh-TW" dirty="0"/>
              <a:t>,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 and </a:t>
            </a:r>
            <a:r>
              <a:rPr lang="en-US" altLang="zh-TW" i="1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***P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 &lt; </a:t>
            </a:r>
            <a:r>
              <a:rPr lang="en-US" altLang="zh-TW" dirty="0" smtClean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0.001. </a:t>
            </a:r>
            <a:r>
              <a:rPr lang="en-US" altLang="zh-TW" dirty="0">
                <a:solidFill>
                  <a:srgbClr val="000000"/>
                </a:solidFill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Data are represented as mean ± SEM.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215166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853181" y="324320"/>
            <a:ext cx="642001" cy="4342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22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22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6364168" y="331574"/>
            <a:ext cx="814458" cy="4342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22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22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6386261" y="3358248"/>
            <a:ext cx="478356" cy="4342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222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TW" altLang="en-US" sz="222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875275" y="3358248"/>
            <a:ext cx="478356" cy="4342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222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sz="222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群組 55"/>
          <p:cNvGrpSpPr/>
          <p:nvPr/>
        </p:nvGrpSpPr>
        <p:grpSpPr>
          <a:xfrm>
            <a:off x="2495183" y="3596462"/>
            <a:ext cx="2728685" cy="1631657"/>
            <a:chOff x="1723329" y="4691019"/>
            <a:chExt cx="3438017" cy="2055812"/>
          </a:xfrm>
        </p:grpSpPr>
        <p:sp>
          <p:nvSpPr>
            <p:cNvPr id="21" name="矩形 20"/>
            <p:cNvSpPr/>
            <p:nvPr/>
          </p:nvSpPr>
          <p:spPr>
            <a:xfrm>
              <a:off x="3203264" y="6246560"/>
              <a:ext cx="1827697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0.8      1.0     0.9      0.2 </a:t>
              </a:r>
            </a:p>
          </p:txBody>
        </p:sp>
        <p:sp>
          <p:nvSpPr>
            <p:cNvPr id="22" name="矩形 21"/>
            <p:cNvSpPr/>
            <p:nvPr/>
          </p:nvSpPr>
          <p:spPr>
            <a:xfrm>
              <a:off x="3203264" y="6445894"/>
              <a:ext cx="1958082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N.D.    1.0     0.9      0.1 </a:t>
              </a:r>
            </a:p>
          </p:txBody>
        </p:sp>
        <p:sp>
          <p:nvSpPr>
            <p:cNvPr id="23" name="矩形 22"/>
            <p:cNvSpPr/>
            <p:nvPr/>
          </p:nvSpPr>
          <p:spPr>
            <a:xfrm>
              <a:off x="1838829" y="6445894"/>
              <a:ext cx="1431810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n-US" altLang="zh-TW" sz="952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p65</a:t>
              </a:r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/GAPDH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1723329" y="6246560"/>
              <a:ext cx="1539423" cy="3009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GDAP1L1/GAPDH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圖片 54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846359" y="4691019"/>
              <a:ext cx="3314987" cy="1655207"/>
            </a:xfrm>
            <a:prstGeom prst="rect">
              <a:avLst/>
            </a:prstGeom>
          </p:spPr>
        </p:pic>
      </p:grpSp>
      <p:grpSp>
        <p:nvGrpSpPr>
          <p:cNvPr id="2" name="群組 1"/>
          <p:cNvGrpSpPr/>
          <p:nvPr/>
        </p:nvGrpSpPr>
        <p:grpSpPr>
          <a:xfrm>
            <a:off x="2529859" y="531955"/>
            <a:ext cx="2590525" cy="1900423"/>
            <a:chOff x="-2853432" y="1615485"/>
            <a:chExt cx="3263941" cy="2394445"/>
          </a:xfrm>
        </p:grpSpPr>
        <p:pic>
          <p:nvPicPr>
            <p:cNvPr id="25" name="圖片 24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-2818843" y="1615485"/>
              <a:ext cx="3229352" cy="1770784"/>
            </a:xfrm>
            <a:prstGeom prst="rect">
              <a:avLst/>
            </a:prstGeom>
          </p:spPr>
        </p:pic>
        <p:sp>
          <p:nvSpPr>
            <p:cNvPr id="26" name="矩形 25"/>
            <p:cNvSpPr/>
            <p:nvPr/>
          </p:nvSpPr>
          <p:spPr>
            <a:xfrm>
              <a:off x="-1521381" y="3462832"/>
              <a:ext cx="1931890" cy="5470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defTabSz="3429213"/>
              <a:r>
                <a:rPr lang="en-US" altLang="zh-TW" sz="1111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1    1.25    0.7    0.62 </a:t>
              </a:r>
            </a:p>
          </p:txBody>
        </p:sp>
        <p:sp>
          <p:nvSpPr>
            <p:cNvPr id="27" name="矩形 26"/>
            <p:cNvSpPr/>
            <p:nvPr/>
          </p:nvSpPr>
          <p:spPr>
            <a:xfrm>
              <a:off x="-2853432" y="3462830"/>
              <a:ext cx="1544608" cy="33171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1111" b="1" dirty="0">
                  <a:latin typeface="Arial" panose="020B0604020202020204" pitchFamily="34" charset="0"/>
                  <a:cs typeface="Arial" panose="020B0604020202020204" pitchFamily="34" charset="0"/>
                </a:rPr>
                <a:t>p-p65/GAPDH</a:t>
              </a:r>
              <a:endParaRPr lang="zh-TW" altLang="en-US" sz="111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群組 3"/>
          <p:cNvGrpSpPr/>
          <p:nvPr/>
        </p:nvGrpSpPr>
        <p:grpSpPr>
          <a:xfrm>
            <a:off x="7315179" y="444196"/>
            <a:ext cx="2919710" cy="2933052"/>
            <a:chOff x="6946967" y="397933"/>
            <a:chExt cx="3678700" cy="3695510"/>
          </a:xfrm>
        </p:grpSpPr>
        <p:sp>
          <p:nvSpPr>
            <p:cNvPr id="13" name="矩形 12"/>
            <p:cNvSpPr/>
            <p:nvPr/>
          </p:nvSpPr>
          <p:spPr>
            <a:xfrm>
              <a:off x="7057573" y="3792506"/>
              <a:ext cx="949668" cy="3009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p-p38/p38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6987924" y="3324331"/>
              <a:ext cx="1034496" cy="3009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p-JNK/JNK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>
              <a:off x="7873790" y="3317589"/>
              <a:ext cx="2675677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0.8    1.0    1.0   1.0   0.5    0.6   0.5 </a:t>
              </a:r>
            </a:p>
          </p:txBody>
        </p:sp>
        <p:sp>
          <p:nvSpPr>
            <p:cNvPr id="16" name="矩形 15"/>
            <p:cNvSpPr/>
            <p:nvPr/>
          </p:nvSpPr>
          <p:spPr>
            <a:xfrm>
              <a:off x="7873790" y="3783767"/>
              <a:ext cx="2751877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0.5    0.5    1.0   0.6   0.5    0.3   0.3 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7873790" y="3559066"/>
              <a:ext cx="2675677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0.4    0.5    1.0   0.8   0.5    0.3   0.4 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6946967" y="3556627"/>
              <a:ext cx="1070851" cy="3009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p-ERK/ERK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圖片 28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7373157" y="397933"/>
              <a:ext cx="3127536" cy="2879087"/>
            </a:xfrm>
            <a:prstGeom prst="rect">
              <a:avLst/>
            </a:prstGeom>
          </p:spPr>
        </p:pic>
      </p:grpSp>
      <p:grpSp>
        <p:nvGrpSpPr>
          <p:cNvPr id="6" name="群組 5"/>
          <p:cNvGrpSpPr/>
          <p:nvPr/>
        </p:nvGrpSpPr>
        <p:grpSpPr>
          <a:xfrm>
            <a:off x="7500226" y="3582002"/>
            <a:ext cx="2329682" cy="1469503"/>
            <a:chOff x="7685991" y="4800601"/>
            <a:chExt cx="2935291" cy="1851505"/>
          </a:xfrm>
        </p:grpSpPr>
        <p:sp>
          <p:nvSpPr>
            <p:cNvPr id="9" name="矩形 8"/>
            <p:cNvSpPr/>
            <p:nvPr/>
          </p:nvSpPr>
          <p:spPr>
            <a:xfrm>
              <a:off x="8894414" y="6351169"/>
              <a:ext cx="1726868" cy="3009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0.1  1.0  0.9  0.8  0.6 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7685991" y="6351167"/>
              <a:ext cx="1398043" cy="3009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952" b="1" dirty="0">
                  <a:latin typeface="Arial" panose="020B0604020202020204" pitchFamily="34" charset="0"/>
                  <a:cs typeface="Arial" panose="020B0604020202020204" pitchFamily="34" charset="0"/>
                </a:rPr>
                <a:t>p-STAT3/STAT3</a:t>
              </a:r>
              <a:endParaRPr lang="zh-TW" altLang="en-US" sz="95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圖片 30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7774736" y="4800601"/>
              <a:ext cx="2731996" cy="1560568"/>
            </a:xfrm>
            <a:prstGeom prst="rect">
              <a:avLst/>
            </a:prstGeom>
          </p:spPr>
        </p:pic>
      </p:grpSp>
      <p:sp>
        <p:nvSpPr>
          <p:cNvPr id="28" name="矩形 27"/>
          <p:cNvSpPr/>
          <p:nvPr/>
        </p:nvSpPr>
        <p:spPr>
          <a:xfrm>
            <a:off x="714051" y="5521130"/>
            <a:ext cx="10785317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1600" b="1" dirty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Supplementary </a:t>
            </a:r>
            <a:r>
              <a:rPr lang="en-US" altLang="zh-TW" sz="1600" b="1" dirty="0" smtClean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Figure </a:t>
            </a:r>
            <a:r>
              <a:rPr lang="en-US" altLang="zh-TW" sz="1600" b="1" dirty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3. </a:t>
            </a: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(A-C) Immunoblotting of MAPK and NF-</a:t>
            </a:r>
            <a:r>
              <a:rPr lang="el-GR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B in IMQ-stimulated THP-1 cells following DMD treatment. (D) Immunoblotting of the phosphorylation of STAT3 in keratinocytes stimulated with the conditioned medium of THP-1. The indicated protein bands were quantified by </a:t>
            </a:r>
            <a:r>
              <a:rPr lang="en-US" altLang="zh-TW" sz="1600" dirty="0" err="1">
                <a:latin typeface="Arial" panose="020B0604020202020204" pitchFamily="34" charset="0"/>
                <a:cs typeface="Arial" panose="020B0604020202020204" pitchFamily="34" charset="0"/>
              </a:rPr>
              <a:t>AlphaView</a:t>
            </a:r>
            <a:r>
              <a:rPr lang="en-US" altLang="zh-TW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 software. The data shown are representative one of three independent experiments. GAPDH is served as an internal control.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2149610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3"/>
          <p:cNvSpPr/>
          <p:nvPr/>
        </p:nvSpPr>
        <p:spPr>
          <a:xfrm>
            <a:off x="4069405" y="3511806"/>
            <a:ext cx="444486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320540"/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6 </a:t>
            </a:r>
            <a:r>
              <a:rPr lang="en-US" altLang="zh-TW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1.0   1.0    0.7    1.1   0.7   0.2   0.4    0.5   0.7   0.6   0.4 </a:t>
            </a:r>
            <a:endParaRPr lang="zh-TW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4069405" y="3771969"/>
            <a:ext cx="443391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320540"/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 </a:t>
            </a:r>
            <a:r>
              <a:rPr lang="en-US" altLang="zh-TW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0.7   1.0    1.0    0.7   0.7   0.3   0.3    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 </a:t>
            </a:r>
            <a:r>
              <a:rPr lang="en-US" altLang="zh-TW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0.3   0.4   0.1 </a:t>
            </a:r>
            <a:endParaRPr lang="zh-TW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4069139" y="4018974"/>
            <a:ext cx="453189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320540"/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 </a:t>
            </a:r>
            <a:r>
              <a:rPr lang="en-US" altLang="zh-TW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0.8   1.0    0.7    0.6   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 </a:t>
            </a:r>
            <a:r>
              <a:rPr lang="en-US" altLang="zh-TW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0.3   0.1    </a:t>
            </a:r>
            <a:r>
              <a:rPr lang="en-US" altLang="zh-TW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 </a:t>
            </a:r>
            <a:r>
              <a:rPr lang="en-US" altLang="zh-TW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0.4   0.5   0.1 </a:t>
            </a:r>
            <a:endParaRPr lang="zh-TW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678123" y="3782739"/>
            <a:ext cx="14911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DAP1L1/GAPDH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2978288" y="3552570"/>
            <a:ext cx="11929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65/GAPDH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2566738" y="4018973"/>
            <a:ext cx="16001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P1-S616/GAPDH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圖片 19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68937" y="1412305"/>
            <a:ext cx="5603929" cy="1909433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198880" y="4755495"/>
            <a:ext cx="972312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b="1" dirty="0" smtClean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Supplementary </a:t>
            </a:r>
            <a:r>
              <a:rPr lang="en-US" altLang="zh-TW" b="1" dirty="0" smtClean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Figure </a:t>
            </a:r>
            <a:r>
              <a:rPr lang="en-US" altLang="zh-TW" b="1" dirty="0" smtClean="0">
                <a:latin typeface="Arial" panose="020B0604020202020204" pitchFamily="34" charset="0"/>
                <a:ea typeface="標楷體" panose="03000509000000000000" pitchFamily="65" charset="-120"/>
                <a:cs typeface="Arial" panose="020B0604020202020204" pitchFamily="34" charset="0"/>
              </a:rPr>
              <a:t>4. </a:t>
            </a:r>
            <a:r>
              <a:rPr lang="en-US" altLang="zh-TW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blotting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of GDAP1L1 and Drp1 S616 in IMQ-stimulated THP-1 cells following DMD treatment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. The indicated protein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bands were quantified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AlphaView</a:t>
            </a:r>
            <a:r>
              <a:rPr lang="en-US" altLang="zh-TW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oftware. The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data shown are representative of three independent experiments. GAPDH is served as an internal control.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803419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群組 3"/>
          <p:cNvGrpSpPr/>
          <p:nvPr/>
        </p:nvGrpSpPr>
        <p:grpSpPr>
          <a:xfrm>
            <a:off x="2559431" y="584203"/>
            <a:ext cx="6912768" cy="4320709"/>
            <a:chOff x="889847" y="-1586693"/>
            <a:chExt cx="6912768" cy="4320709"/>
          </a:xfrm>
        </p:grpSpPr>
        <p:grpSp>
          <p:nvGrpSpPr>
            <p:cNvPr id="5" name="群組 4"/>
            <p:cNvGrpSpPr/>
            <p:nvPr/>
          </p:nvGrpSpPr>
          <p:grpSpPr>
            <a:xfrm>
              <a:off x="889847" y="-1586693"/>
              <a:ext cx="6912768" cy="4320709"/>
              <a:chOff x="-36512" y="1196523"/>
              <a:chExt cx="6912768" cy="4320709"/>
            </a:xfrm>
          </p:grpSpPr>
          <p:pic>
            <p:nvPicPr>
              <p:cNvPr id="10" name="Picture 2" descr="E:\Clemence LSM780\2018 THP1+IMQ+0-4h-gdap1+mito-red\201804 THP1+Q-Mito+GDAP1\20180420 THP1Q-0 h-2.tif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 bwMode="auto">
              <a:xfrm>
                <a:off x="-36512" y="1203964"/>
                <a:ext cx="2277319" cy="213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" name="Picture 3" descr="E:\Clemence LSM780\2018 THP1+IMQ+0-4h-gdap1+mito-red\201804 THP1+Q-Mito+GDAP1\20180421 THP1Q-10 min-2.tif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82440" y="1203964"/>
                <a:ext cx="2277319" cy="213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" name="Picture 4" descr="E:\Clemence LSM780\2018 THP1+IMQ+0-4h-gdap1+mito-red\201804 THP1+Q-Mito+GDAP1\20180421 THP1Q-20 min-2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98937" y="1203964"/>
                <a:ext cx="2277319" cy="213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" name="Picture 5" descr="E:\Clemence LSM780\2018 THP1+IMQ+0-4h-gdap1+mito-red\201804 THP1+Q-Mito+GDAP1\20180421 THP1Q-30 min-1.tif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36512" y="3382246"/>
                <a:ext cx="2277319" cy="213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" name="Picture 6" descr="E:\Clemence LSM780\2018 THP1+IMQ+0-4h-gdap1+mito-red\201804 THP1+Q-Mito+GDAP1\20180421 THP1Q-1 h-1.tif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86188" y="3382245"/>
                <a:ext cx="2277319" cy="213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" name="Picture 9" descr="E:\Clemence LSM780\2018 THP1+IMQ+0-4h-gdap1+mito-red\201804 THP1+Q-Mito+GDAP1\20180421 THP1Q-2 h-1.tif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98937" y="3382245"/>
                <a:ext cx="2277319" cy="213498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6" name="矩形 15"/>
              <p:cNvSpPr/>
              <p:nvPr/>
            </p:nvSpPr>
            <p:spPr>
              <a:xfrm>
                <a:off x="1637475" y="1196523"/>
                <a:ext cx="559265" cy="261039"/>
              </a:xfrm>
              <a:prstGeom prst="rect">
                <a:avLst/>
              </a:prstGeom>
            </p:spPr>
            <p:txBody>
              <a:bodyPr wrap="none" lIns="45153" tIns="22577" rIns="45153" bIns="22577">
                <a:spAutoFit/>
              </a:bodyPr>
              <a:lstStyle/>
              <a:p>
                <a:r>
                  <a:rPr lang="en-US" altLang="zh-TW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 min</a:t>
                </a:r>
                <a:endParaRPr lang="zh-TW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3889093" y="1234198"/>
                <a:ext cx="658651" cy="261039"/>
              </a:xfrm>
              <a:prstGeom prst="rect">
                <a:avLst/>
              </a:prstGeom>
            </p:spPr>
            <p:txBody>
              <a:bodyPr wrap="none" lIns="45153" tIns="22577" rIns="45153" bIns="22577">
                <a:spAutoFit/>
              </a:bodyPr>
              <a:lstStyle/>
              <a:p>
                <a:r>
                  <a:rPr lang="en-US" altLang="zh-TW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 min</a:t>
                </a:r>
                <a:endParaRPr lang="zh-TW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6166922" y="1203964"/>
                <a:ext cx="658651" cy="261039"/>
              </a:xfrm>
              <a:prstGeom prst="rect">
                <a:avLst/>
              </a:prstGeom>
            </p:spPr>
            <p:txBody>
              <a:bodyPr wrap="none" lIns="45153" tIns="22577" rIns="45153" bIns="22577">
                <a:spAutoFit/>
              </a:bodyPr>
              <a:lstStyle/>
              <a:p>
                <a:r>
                  <a:rPr lang="en-US" altLang="zh-TW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 min</a:t>
                </a:r>
                <a:endParaRPr lang="zh-TW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矩形 18"/>
              <p:cNvSpPr/>
              <p:nvPr/>
            </p:nvSpPr>
            <p:spPr>
              <a:xfrm>
                <a:off x="1582549" y="3390634"/>
                <a:ext cx="658651" cy="261039"/>
              </a:xfrm>
              <a:prstGeom prst="rect">
                <a:avLst/>
              </a:prstGeom>
            </p:spPr>
            <p:txBody>
              <a:bodyPr wrap="none" lIns="45153" tIns="22577" rIns="45153" bIns="22577">
                <a:spAutoFit/>
              </a:bodyPr>
              <a:lstStyle/>
              <a:p>
                <a:r>
                  <a:rPr lang="en-US" altLang="zh-TW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 min</a:t>
                </a:r>
                <a:endParaRPr lang="zh-TW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矩形 19"/>
              <p:cNvSpPr/>
              <p:nvPr/>
            </p:nvSpPr>
            <p:spPr>
              <a:xfrm>
                <a:off x="4119106" y="3390634"/>
                <a:ext cx="349272" cy="261039"/>
              </a:xfrm>
              <a:prstGeom prst="rect">
                <a:avLst/>
              </a:prstGeom>
            </p:spPr>
            <p:txBody>
              <a:bodyPr wrap="none" lIns="45153" tIns="22577" rIns="45153" bIns="22577">
                <a:spAutoFit/>
              </a:bodyPr>
              <a:lstStyle/>
              <a:p>
                <a:r>
                  <a:rPr lang="en-US" altLang="zh-TW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 h</a:t>
                </a:r>
                <a:endParaRPr lang="zh-TW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6456997" y="3390634"/>
                <a:ext cx="349272" cy="261039"/>
              </a:xfrm>
              <a:prstGeom prst="rect">
                <a:avLst/>
              </a:prstGeom>
            </p:spPr>
            <p:txBody>
              <a:bodyPr wrap="none" lIns="45153" tIns="22577" rIns="45153" bIns="22577">
                <a:spAutoFit/>
              </a:bodyPr>
              <a:lstStyle/>
              <a:p>
                <a:r>
                  <a:rPr lang="en-US" altLang="zh-TW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 h</a:t>
                </a:r>
                <a:endParaRPr lang="zh-TW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群組 5"/>
            <p:cNvGrpSpPr/>
            <p:nvPr/>
          </p:nvGrpSpPr>
          <p:grpSpPr>
            <a:xfrm>
              <a:off x="891187" y="-1559670"/>
              <a:ext cx="1386406" cy="604521"/>
              <a:chOff x="553415" y="-2664779"/>
              <a:chExt cx="1386406" cy="604521"/>
            </a:xfrm>
          </p:grpSpPr>
          <p:sp>
            <p:nvSpPr>
              <p:cNvPr id="7" name="文字方塊 6"/>
              <p:cNvSpPr txBox="1"/>
              <p:nvPr/>
            </p:nvSpPr>
            <p:spPr>
              <a:xfrm>
                <a:off x="553415" y="-2664779"/>
                <a:ext cx="721665" cy="230261"/>
              </a:xfrm>
              <a:prstGeom prst="rect">
                <a:avLst/>
              </a:prstGeom>
              <a:noFill/>
            </p:spPr>
            <p:txBody>
              <a:bodyPr wrap="square" lIns="45153" tIns="22577" rIns="45153" bIns="22577" rtlCol="0">
                <a:spAutoFit/>
              </a:bodyPr>
              <a:lstStyle/>
              <a:p>
                <a:r>
                  <a:rPr lang="en-US" altLang="zh-TW" sz="1200" b="1" dirty="0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zh-TW" altLang="en-US" sz="12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字方塊 7"/>
              <p:cNvSpPr txBox="1"/>
              <p:nvPr/>
            </p:nvSpPr>
            <p:spPr>
              <a:xfrm>
                <a:off x="553415" y="-2494522"/>
                <a:ext cx="1386406" cy="230261"/>
              </a:xfrm>
              <a:prstGeom prst="rect">
                <a:avLst/>
              </a:prstGeom>
              <a:noFill/>
            </p:spPr>
            <p:txBody>
              <a:bodyPr wrap="square" lIns="45153" tIns="22577" rIns="45153" bIns="22577" rtlCol="0">
                <a:spAutoFit/>
              </a:bodyPr>
              <a:lstStyle/>
              <a:p>
                <a:r>
                  <a:rPr lang="en-US" altLang="zh-TW" sz="1200" b="1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toTracker</a:t>
                </a:r>
                <a:r>
                  <a:rPr lang="en-US" altLang="zh-TW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Red</a:t>
                </a:r>
                <a:endParaRPr lang="zh-TW" alt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字方塊 8"/>
              <p:cNvSpPr txBox="1"/>
              <p:nvPr/>
            </p:nvSpPr>
            <p:spPr>
              <a:xfrm>
                <a:off x="553415" y="-2290519"/>
                <a:ext cx="995985" cy="230261"/>
              </a:xfrm>
              <a:prstGeom prst="rect">
                <a:avLst/>
              </a:prstGeom>
              <a:noFill/>
            </p:spPr>
            <p:txBody>
              <a:bodyPr wrap="square" lIns="45153" tIns="22577" rIns="45153" bIns="22577" rtlCol="0">
                <a:spAutoFit/>
              </a:bodyPr>
              <a:lstStyle/>
              <a:p>
                <a:r>
                  <a:rPr lang="en-US" altLang="zh-TW" sz="1200" b="1" dirty="0" smtClean="0">
                    <a:solidFill>
                      <a:srgbClr val="0099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DAP1L1</a:t>
                </a:r>
                <a:endParaRPr lang="zh-TW" altLang="en-US" sz="1200" b="1" dirty="0">
                  <a:solidFill>
                    <a:srgbClr val="0099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" name="矩形 1"/>
          <p:cNvSpPr/>
          <p:nvPr/>
        </p:nvSpPr>
        <p:spPr>
          <a:xfrm>
            <a:off x="650950" y="5201518"/>
            <a:ext cx="1073218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b="1" dirty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Supplementary </a:t>
            </a:r>
            <a:r>
              <a:rPr lang="en-US" altLang="zh-TW" b="1" dirty="0" smtClean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F</a:t>
            </a:r>
            <a:r>
              <a:rPr lang="en-US" altLang="zh-TW" b="1" dirty="0" smtClean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gure </a:t>
            </a:r>
            <a:r>
              <a:rPr lang="en-US" altLang="zh-TW" b="1" dirty="0" smtClean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5. </a:t>
            </a:r>
            <a:r>
              <a:rPr lang="en-US" altLang="zh-TW" b="1" dirty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The subcellular localization of </a:t>
            </a:r>
            <a:r>
              <a:rPr lang="en-US" altLang="zh-TW" b="1" dirty="0" smtClean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GDAP1L1 </a:t>
            </a:r>
            <a:r>
              <a:rPr lang="en-US" altLang="zh-TW" b="1" dirty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upon </a:t>
            </a:r>
            <a:r>
              <a:rPr lang="en-US" altLang="zh-TW" b="1" dirty="0" smtClean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IMQ stimulation. </a:t>
            </a:r>
            <a:r>
              <a:rPr lang="en-US" altLang="zh-TW" b="1" dirty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/>
            </a:r>
            <a:br>
              <a:rPr lang="en-US" altLang="zh-TW" b="1" dirty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</a:b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majority </a:t>
            </a:r>
            <a:r>
              <a:rPr lang="en-US" altLang="zh-TW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TW" smtClean="0">
                <a:latin typeface="Arial" panose="020B0604020202020204" pitchFamily="34" charset="0"/>
                <a:cs typeface="Arial" panose="020B0604020202020204" pitchFamily="34" charset="0"/>
              </a:rPr>
              <a:t>GDAP1L1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is redistributed to mitochondria two hours after treatment with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10 µM IMQ in THP1 cells.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Scale 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bars,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10 µm. </a:t>
            </a:r>
            <a:r>
              <a:rPr lang="en-US" altLang="zh-TW" b="1" dirty="0" smtClean="0">
                <a:solidFill>
                  <a:srgbClr val="000000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10163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3</TotalTime>
  <Words>286</Words>
  <Application>Microsoft Office PowerPoint</Application>
  <PresentationFormat>自訂</PresentationFormat>
  <Paragraphs>41</Paragraphs>
  <Slides>5</Slides>
  <Notes>0</Notes>
  <HiddenSlides>0</HiddenSlides>
  <MMClips>0</MMClips>
  <ScaleCrop>false</ScaleCrop>
  <HeadingPairs>
    <vt:vector size="6" baseType="variant">
      <vt:variant>
        <vt:lpstr>佈景主題</vt:lpstr>
      </vt:variant>
      <vt:variant>
        <vt:i4>1</vt:i4>
      </vt:variant>
      <vt:variant>
        <vt:lpstr>內嵌 OLE 伺服程式</vt:lpstr>
      </vt:variant>
      <vt:variant>
        <vt:i4>0</vt:i4>
      </vt:variant>
      <vt:variant>
        <vt:lpstr>投影片標題</vt:lpstr>
      </vt:variant>
      <vt:variant>
        <vt:i4>5</vt:i4>
      </vt:variant>
    </vt:vector>
  </HeadingPairs>
  <TitlesOfParts>
    <vt:vector size="6" baseType="lpstr">
      <vt:lpstr>Office 佈景主題</vt:lpstr>
      <vt:lpstr>投影片 1</vt:lpstr>
      <vt:lpstr>投影片 2</vt:lpstr>
      <vt:lpstr>投影片 3</vt:lpstr>
      <vt:lpstr>投影片 4</vt:lpstr>
      <vt:lpstr>投影片 5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士億 莊</dc:creator>
  <cp:lastModifiedBy>jyfang</cp:lastModifiedBy>
  <cp:revision>33</cp:revision>
  <dcterms:created xsi:type="dcterms:W3CDTF">2020-02-11T03:17:50Z</dcterms:created>
  <dcterms:modified xsi:type="dcterms:W3CDTF">2021-04-26T08:17:25Z</dcterms:modified>
</cp:coreProperties>
</file>